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54" d="100"/>
          <a:sy n="54" d="100"/>
        </p:scale>
        <p:origin x="78" y="14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02197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990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13089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00281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6193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2731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24218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7617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44733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5305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34942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68D6D-8240-4C88-B2AB-2755720A672B}" type="datetimeFigureOut">
              <a:rPr lang="en-IN" smtClean="0"/>
              <a:t>18-09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317C3-697E-4C31-8350-0AB1942C5E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89861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190" y="455476"/>
            <a:ext cx="11709456" cy="587420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627120" y="6329680"/>
            <a:ext cx="57655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upplementary figure </a:t>
            </a:r>
            <a:r>
              <a:rPr lang="en-US" dirty="0" smtClean="0"/>
              <a:t>1: </a:t>
            </a:r>
            <a:r>
              <a:rPr lang="en-US" dirty="0"/>
              <a:t>Pathway analysis using </a:t>
            </a:r>
            <a:r>
              <a:rPr lang="en-US" dirty="0" err="1"/>
              <a:t>Reactome</a:t>
            </a:r>
            <a:r>
              <a:rPr lang="en-US" dirty="0"/>
              <a:t>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902563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9509" y="307777"/>
            <a:ext cx="3944332" cy="166575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7440" y="293521"/>
            <a:ext cx="3944331" cy="166575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9509" y="2469133"/>
            <a:ext cx="3944333" cy="166575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308388" y="32399"/>
            <a:ext cx="2251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Reactome</a:t>
            </a:r>
            <a:r>
              <a:rPr lang="en-US" sz="1400" b="1" dirty="0"/>
              <a:t> 2022</a:t>
            </a:r>
            <a:endParaRPr lang="en-IN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308388" y="2137238"/>
            <a:ext cx="2251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Bioplanet</a:t>
            </a:r>
            <a:r>
              <a:rPr lang="en-US" sz="1400" b="1" dirty="0"/>
              <a:t> 2019</a:t>
            </a:r>
            <a:endParaRPr lang="en-IN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18232" y="0"/>
            <a:ext cx="29888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lsevier Pathway collection</a:t>
            </a:r>
            <a:endParaRPr lang="en-IN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0" y="648866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2: </a:t>
            </a:r>
            <a:r>
              <a:rPr lang="en-US" dirty="0"/>
              <a:t>Pathway enrichment study using </a:t>
            </a:r>
            <a:r>
              <a:rPr lang="en-US" dirty="0" err="1"/>
              <a:t>EnrichR</a:t>
            </a:r>
            <a:r>
              <a:rPr lang="en-US" dirty="0"/>
              <a:t> for the genes co-related with lncRNAs for different databases</a:t>
            </a:r>
            <a:endParaRPr lang="en-IN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5029" y="4611601"/>
            <a:ext cx="4200244" cy="177383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7440" y="2426756"/>
            <a:ext cx="4197541" cy="177269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6118232" y="2118979"/>
            <a:ext cx="2251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anther 2016</a:t>
            </a:r>
            <a:endParaRPr lang="en-IN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308388" y="4303824"/>
            <a:ext cx="2251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I-Nature 2016</a:t>
            </a:r>
            <a:endParaRPr lang="en-IN" sz="1400" b="1" dirty="0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7440" y="4625351"/>
            <a:ext cx="3947897" cy="1667261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6118232" y="4317574"/>
            <a:ext cx="2251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MiSigDB</a:t>
            </a:r>
            <a:r>
              <a:rPr lang="en-US" sz="1400" b="1" dirty="0"/>
              <a:t> Hallmark</a:t>
            </a:r>
            <a:endParaRPr lang="en-IN" sz="1400" b="1" dirty="0"/>
          </a:p>
        </p:txBody>
      </p:sp>
    </p:spTree>
    <p:extLst>
      <p:ext uri="{BB962C8B-B14F-4D97-AF65-F5344CB8AC3E}">
        <p14:creationId xmlns:p14="http://schemas.microsoft.com/office/powerpoint/2010/main" val="4073706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406404"/>
            <a:ext cx="3948112" cy="232813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r="6329"/>
          <a:stretch/>
        </p:blipFill>
        <p:spPr>
          <a:xfrm>
            <a:off x="8075142" y="97594"/>
            <a:ext cx="4019428" cy="253033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49386" y="71219"/>
            <a:ext cx="4380470" cy="258309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6281"/>
            <a:ext cx="4125756" cy="243289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82919" y="2680497"/>
            <a:ext cx="3776663" cy="222703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42545" y="2605585"/>
            <a:ext cx="3948111" cy="232813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0" y="4698704"/>
            <a:ext cx="3661788" cy="2159296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145203" y="70209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2</a:t>
            </a:r>
            <a:endParaRPr lang="en-IN" sz="900" dirty="0"/>
          </a:p>
        </p:txBody>
      </p:sp>
      <p:sp>
        <p:nvSpPr>
          <p:cNvPr id="16" name="TextBox 15"/>
          <p:cNvSpPr txBox="1"/>
          <p:nvPr/>
        </p:nvSpPr>
        <p:spPr>
          <a:xfrm>
            <a:off x="7304183" y="781815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50</a:t>
            </a:r>
            <a:endParaRPr lang="en-IN" sz="900" dirty="0"/>
          </a:p>
        </p:txBody>
      </p:sp>
      <p:sp>
        <p:nvSpPr>
          <p:cNvPr id="17" name="TextBox 16"/>
          <p:cNvSpPr txBox="1"/>
          <p:nvPr/>
        </p:nvSpPr>
        <p:spPr>
          <a:xfrm>
            <a:off x="11331575" y="79455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5</a:t>
            </a:r>
            <a:endParaRPr lang="en-IN" sz="900" dirty="0"/>
          </a:p>
        </p:txBody>
      </p:sp>
      <p:sp>
        <p:nvSpPr>
          <p:cNvPr id="18" name="TextBox 17"/>
          <p:cNvSpPr txBox="1"/>
          <p:nvPr/>
        </p:nvSpPr>
        <p:spPr>
          <a:xfrm>
            <a:off x="2822369" y="525442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8</a:t>
            </a:r>
            <a:endParaRPr lang="en-IN" sz="900" dirty="0"/>
          </a:p>
        </p:txBody>
      </p:sp>
      <p:sp>
        <p:nvSpPr>
          <p:cNvPr id="19" name="TextBox 18"/>
          <p:cNvSpPr txBox="1"/>
          <p:nvPr/>
        </p:nvSpPr>
        <p:spPr>
          <a:xfrm>
            <a:off x="10997214" y="324029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4</a:t>
            </a:r>
            <a:endParaRPr lang="en-IN" sz="900" dirty="0"/>
          </a:p>
        </p:txBody>
      </p:sp>
      <p:sp>
        <p:nvSpPr>
          <p:cNvPr id="20" name="TextBox 19"/>
          <p:cNvSpPr txBox="1"/>
          <p:nvPr/>
        </p:nvSpPr>
        <p:spPr>
          <a:xfrm>
            <a:off x="6837775" y="3249490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49</a:t>
            </a:r>
            <a:endParaRPr lang="en-IN" sz="900" dirty="0"/>
          </a:p>
        </p:txBody>
      </p:sp>
      <p:sp>
        <p:nvSpPr>
          <p:cNvPr id="21" name="TextBox 20"/>
          <p:cNvSpPr txBox="1"/>
          <p:nvPr/>
        </p:nvSpPr>
        <p:spPr>
          <a:xfrm>
            <a:off x="3046148" y="2999060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12</a:t>
            </a:r>
            <a:endParaRPr lang="en-IN" sz="900" dirty="0"/>
          </a:p>
        </p:txBody>
      </p:sp>
      <p:sp>
        <p:nvSpPr>
          <p:cNvPr id="22" name="Rectangle 21"/>
          <p:cNvSpPr/>
          <p:nvPr/>
        </p:nvSpPr>
        <p:spPr>
          <a:xfrm>
            <a:off x="3368982" y="6376345"/>
            <a:ext cx="87379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3: Relapse rate in T-ALL patients (N=51) expressing different lncRNAs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160695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3230" y="403728"/>
            <a:ext cx="4093768" cy="241402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03728"/>
            <a:ext cx="4044204" cy="23848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11503" y="386932"/>
            <a:ext cx="4103716" cy="24198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965" y="3416621"/>
            <a:ext cx="4200734" cy="247710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90704" y="3285954"/>
            <a:ext cx="4422324" cy="260777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42475" y="3416620"/>
            <a:ext cx="4200736" cy="247710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1286132" y="4106911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=0.68</a:t>
            </a:r>
            <a:endParaRPr lang="en-IN" sz="900" dirty="0"/>
          </a:p>
        </p:txBody>
      </p:sp>
      <p:sp>
        <p:nvSpPr>
          <p:cNvPr id="10" name="TextBox 9"/>
          <p:cNvSpPr txBox="1"/>
          <p:nvPr/>
        </p:nvSpPr>
        <p:spPr>
          <a:xfrm>
            <a:off x="7243031" y="4082242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67</a:t>
            </a:r>
            <a:endParaRPr lang="en-IN" sz="900" dirty="0"/>
          </a:p>
        </p:txBody>
      </p:sp>
      <p:sp>
        <p:nvSpPr>
          <p:cNvPr id="11" name="TextBox 10"/>
          <p:cNvSpPr txBox="1"/>
          <p:nvPr/>
        </p:nvSpPr>
        <p:spPr>
          <a:xfrm>
            <a:off x="3280220" y="410691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2</a:t>
            </a:r>
            <a:endParaRPr lang="en-IN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11159118" y="1064198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87</a:t>
            </a:r>
            <a:endParaRPr lang="en-IN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7007483" y="1087381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</a:t>
            </a:r>
            <a:r>
              <a:rPr lang="en-US" sz="900" dirty="0" smtClean="0"/>
              <a:t>=0.52</a:t>
            </a:r>
            <a:endParaRPr lang="en-IN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2998732" y="1064198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=0.69</a:t>
            </a:r>
            <a:endParaRPr lang="en-IN" sz="900" dirty="0"/>
          </a:p>
        </p:txBody>
      </p:sp>
      <p:sp>
        <p:nvSpPr>
          <p:cNvPr id="15" name="Rectangle 14"/>
          <p:cNvSpPr/>
          <p:nvPr/>
        </p:nvSpPr>
        <p:spPr>
          <a:xfrm>
            <a:off x="499010" y="6302384"/>
            <a:ext cx="90151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4: Overall survival in T-ALL patients (N=51) expressing different lncRNAs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806513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0</TotalTime>
  <Words>84</Words>
  <Application>Microsoft Office PowerPoint</Application>
  <PresentationFormat>Widescreen</PresentationFormat>
  <Paragraphs>2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kaj Sharma</dc:creator>
  <cp:lastModifiedBy>DELL</cp:lastModifiedBy>
  <cp:revision>17</cp:revision>
  <cp:lastPrinted>2023-09-18T05:38:01Z</cp:lastPrinted>
  <dcterms:created xsi:type="dcterms:W3CDTF">2023-09-09T08:02:10Z</dcterms:created>
  <dcterms:modified xsi:type="dcterms:W3CDTF">2023-09-18T05:38:06Z</dcterms:modified>
</cp:coreProperties>
</file>